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EE69001-98D3-49E3-B1C8-F86AC760EB8B}"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2143080" y="685800"/>
            <a:ext cx="2571840" cy="3429000"/>
          </a:xfrm>
          <a:prstGeom prst="rect">
            <a:avLst/>
          </a:prstGeom>
          <a:ln w="0">
            <a:noFill/>
          </a:ln>
        </p:spPr>
      </p:sp>
      <p:sp>
        <p:nvSpPr>
          <p:cNvPr id="53"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4"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fld id="{647A9C99-9AD5-4C19-BE60-6791A9B44EF4}"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 name="PlaceHolder 1"/>
          <p:cNvSpPr>
            <a:spLocks noGrp="1"/>
          </p:cNvSpPr>
          <p:nvPr>
            <p:ph type="sldImg"/>
          </p:nvPr>
        </p:nvSpPr>
        <p:spPr>
          <a:xfrm>
            <a:off x="2143080" y="685800"/>
            <a:ext cx="2571840" cy="3429000"/>
          </a:xfrm>
          <a:prstGeom prst="rect">
            <a:avLst/>
          </a:prstGeom>
          <a:ln w="0">
            <a:noFill/>
          </a:ln>
        </p:spPr>
      </p:sp>
      <p:sp>
        <p:nvSpPr>
          <p:cNvPr id="56"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7"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1160"/>
                <a:tab algn="l" pos="1822320"/>
                <a:tab algn="l" pos="2733840"/>
                <a:tab algn="l" pos="3645000"/>
                <a:tab algn="l" pos="4556160"/>
                <a:tab algn="l" pos="5467320"/>
                <a:tab algn="l" pos="6378480"/>
                <a:tab algn="l" pos="7289640"/>
                <a:tab algn="l" pos="8201160"/>
                <a:tab algn="l" pos="9112320"/>
                <a:tab algn="l" pos="10023480"/>
                <a:tab algn="l" pos="10934640"/>
              </a:tabLst>
            </a:pPr>
            <a:fld id="{E18F6D92-9B52-4E94-A58E-3B007B08BD3B}"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AB07C1B-4966-4034-AD58-454E5F909D9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EA46980-9280-4D0A-968D-17F3ECF9C6B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EDD3B4C-00C7-4C47-ABF9-8D0666FB8C2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51EA027-76A7-42B6-9C55-9B2CBA49604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91603AA-57B6-40A0-B57B-26097B6BEF6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2152CE6-33D7-48B1-A878-A932FD46FBD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74743AC-7DC0-4709-9DFD-A0AE37D85D4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0C4C409-763D-436C-83A2-4A215C4CFBD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841DAD3-37AB-40FA-BF12-845B06B6DAF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7B5317B-A133-4D18-9555-E10E7A4E4AD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27E1756-DFF2-4A5F-B1FA-EE7F39DBF89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1735085-E84E-4D0A-B3DE-591F4F5CA96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F593DDD-A0B4-49B1-8FF4-15355A1360EC}"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8" name=""/>
          <p:cNvGraphicFramePr/>
          <p:nvPr/>
        </p:nvGraphicFramePr>
        <p:xfrm>
          <a:off x="533520" y="1101600"/>
          <a:ext cx="5715000" cy="5627880"/>
        </p:xfrm>
        <a:graphic>
          <a:graphicData uri="http://schemas.openxmlformats.org/drawingml/2006/table">
            <a:tbl>
              <a:tblPr/>
              <a:tblGrid>
                <a:gridCol w="392040"/>
                <a:gridCol w="1251000"/>
                <a:gridCol w="301680"/>
                <a:gridCol w="422280"/>
                <a:gridCol w="1282680"/>
                <a:gridCol w="315720"/>
                <a:gridCol w="444600"/>
                <a:gridCol w="1305000"/>
              </a:tblGrid>
              <a:tr h="22572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1</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TLTWHTKTPVR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34</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TCPRYICQAPH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67</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HILPWKIPAHSA</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4</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HFKYHHHMLRS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35</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SLVPSYHRSLST</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68</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HSYMPPLPPQLY</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35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5</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SHEIYVGSDGFR</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36</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FHKHSPRSPIFI</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69</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STAQPRFGPSSL</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72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6</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HISPISAYPWVS</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37</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TNVPNPLQPNPR</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71</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NISSIRPTLVEV</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7</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HGSKHMPQQSTH</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38</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LSPLYPQLLGLA</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73</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DAMIMKKHWHRF</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9</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WHKHIPSPRASS</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39</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GLLHHKHHRSPY</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74</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YPTSNIIPSIWS</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10</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HFKHQHSYARP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41</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FHKHSPRSPIFI</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75</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SMTHLYTDLWQ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12</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AMYYPLWPSLVY</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42</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TCPRYICQAPH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76</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YKAPRHLASHLF</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392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14</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LTYQPLFPTLVY</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44</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AYSPISTVTQPY</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77</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SYSRTVPPAQW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15</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FHKEWRTHFQQR</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47</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APGYARLPSLMS</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78</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LEAPRPTPAVPM</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72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17</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FPKAFHHHKIYK</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48</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SPRTPDLTSLL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79</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NAISWFPMHLAH</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18</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LITNNPGRLPPQ</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49</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TTGLVQPTAID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80</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GPLLVLNSHSFD</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19</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TCPRYICQAPH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50</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YALKHLPESTI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81</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QNNLDYIGLYAR</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392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20</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CPLPYPLCLPHG</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51</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NVHIRQPLGASS</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82</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DLQALLPNYPRI</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21</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WHQSWWAARLGQ</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52</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SHWWARVPFYP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83</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FHKYPRPVAMTF</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22</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WHKHPHAVFNAR</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53</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GSAVASTLPLGQ</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84</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HFNHTIPLSAN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23</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LSPLYPQLLGLA</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55</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LTHNKMHREQAS</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85</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QHVQHQLASTGE</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26</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QTTTAPRHTLWL</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57</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SMMMPDQLSLGR</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86</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TTNIYFNTPAEV</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72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27</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HLPRHHWQWPSR</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59</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AVGGQTPIRAKI</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87</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HILSPSGSPRMS</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35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28</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LSPLYPQLLGLA</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60</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LLHAPYDHSVS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89</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ELTWPHVHRKPS</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72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29</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TCPRYICQAPHP</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61</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IPTMPHPSTARE</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90</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ERQGTPYSMYVL</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30</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SSPFXWQSFSEV</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62</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SPPTPHHPHPRL</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95</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IPHPHRWPLHSH</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31</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HSFHSHVHLKNR</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64</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SAPYKPLLHHFG</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rowSpan="3">
                  <a:txBody>
                    <a:bodyPr lIns="9360" rIns="9360" tIns="9360" bIns="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96</a:t>
                      </a:r>
                      <a:endParaRPr b="0" lang="en-US" sz="1100" spc="-1" strike="noStrike">
                        <a:solidFill>
                          <a:srgbClr val="000000"/>
                        </a:solidFill>
                        <a:latin typeface="Arial"/>
                      </a:endParaRPr>
                    </a:p>
                  </a:txBody>
                  <a:tcPr anchor="t" marL="9360" marR="9360">
                    <a:lnL w="2880">
                      <a:solidFill>
                        <a:srgbClr val="000000"/>
                      </a:solidFill>
                    </a:lnL>
                    <a:lnR w="2880">
                      <a:solidFill>
                        <a:srgbClr val="000000"/>
                      </a:solidFill>
                    </a:lnR>
                    <a:lnT w="2880">
                      <a:solidFill>
                        <a:srgbClr val="000000"/>
                      </a:solidFill>
                    </a:lnT>
                    <a:lnB w="2880">
                      <a:solidFill>
                        <a:srgbClr val="000000"/>
                      </a:solidFill>
                    </a:lnB>
                    <a:noFill/>
                  </a:tcPr>
                </a:tc>
                <a:tc rowSpan="3">
                  <a:txBody>
                    <a:bodyPr lIns="9360" rIns="9360" tIns="9360" bIns="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LHSSVQLTYPLP</a:t>
                      </a:r>
                      <a:endParaRPr b="0" lang="en-US" sz="1100" spc="-1" strike="noStrike">
                        <a:solidFill>
                          <a:srgbClr val="000000"/>
                        </a:solidFill>
                        <a:latin typeface="Arial"/>
                      </a:endParaRPr>
                    </a:p>
                  </a:txBody>
                  <a:tcPr anchor="t" marL="9360" marR="9360">
                    <a:lnL w="2880">
                      <a:solidFill>
                        <a:srgbClr val="000000"/>
                      </a:solidFill>
                    </a:lnL>
                    <a:lnR w="2880">
                      <a:solidFill>
                        <a:srgbClr val="000000"/>
                      </a:solidFill>
                    </a:lnR>
                    <a:lnT w="2880">
                      <a:solidFill>
                        <a:srgbClr val="000000"/>
                      </a:solidFill>
                    </a:lnT>
                    <a:lnB w="2880">
                      <a:solidFill>
                        <a:srgbClr val="000000"/>
                      </a:solidFill>
                    </a:lnB>
                    <a:noFill/>
                  </a:tcPr>
                </a:tc>
              </a:tr>
              <a:tr h="22536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32</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HISPISAYPWVS</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65</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IQSGTPHPPLRS</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2392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33</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WHSSWKSRVVPT</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66</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100" spc="-1" strike="noStrike">
                          <a:solidFill>
                            <a:srgbClr val="000000"/>
                          </a:solidFill>
                          <a:latin typeface="Courier New"/>
                          <a:ea typeface="Courier New"/>
                        </a:rPr>
                        <a:t>QSMLGFISVSAK</a:t>
                      </a:r>
                      <a:endParaRPr b="0" lang="en-US" sz="1100" spc="-1" strike="noStrike">
                        <a:solidFill>
                          <a:srgbClr val="000000"/>
                        </a:solidFill>
                        <a:latin typeface="Arial"/>
                      </a:endParaRPr>
                    </a:p>
                  </a:txBody>
                  <a:tcPr anchor="b"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5760" rIns="5760" tIns="57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5760" marR="5760">
                    <a:lnL w="2880">
                      <a:solidFill>
                        <a:srgbClr val="000000"/>
                      </a:solidFill>
                    </a:lnL>
                    <a:lnR w="2880">
                      <a:solidFill>
                        <a:srgbClr val="000000"/>
                      </a:solidFill>
                    </a:lnR>
                    <a:lnT>
                      <a:noFill/>
                    </a:lnT>
                    <a:lnB>
                      <a:no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bl>
          </a:graphicData>
        </a:graphic>
      </p:graphicFrame>
      <p:sp>
        <p:nvSpPr>
          <p:cNvPr id="49" name="Rectangle 10"/>
          <p:cNvSpPr/>
          <p:nvPr/>
        </p:nvSpPr>
        <p:spPr>
          <a:xfrm>
            <a:off x="533520" y="7273800"/>
            <a:ext cx="5715000" cy="1096200"/>
          </a:xfrm>
          <a:prstGeom prst="rect">
            <a:avLst/>
          </a:prstGeom>
          <a:noFill/>
          <a:ln w="0">
            <a:noFill/>
          </a:ln>
        </p:spPr>
        <p:style>
          <a:lnRef idx="0"/>
          <a:fillRef idx="0"/>
          <a:effectRef idx="0"/>
          <a:fontRef idx="minor"/>
        </p:style>
        <p:txBody>
          <a:bodyPr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rPr>
              <a:t>Additiona file 1a. Phage display analysis of AC3 protein. </a:t>
            </a:r>
            <a:r>
              <a:rPr b="0" lang="en-US" sz="1100" spc="-1" strike="noStrike">
                <a:solidFill>
                  <a:srgbClr val="000000"/>
                </a:solidFill>
                <a:latin typeface="Calibri"/>
              </a:rPr>
              <a:t>Representative peptides that are interacting with AC3 are shown in a table.  DNA sequence of the M13 phage was translated with unique M13 phage genetic code.  Peptides that were common in MBP and MBP-AC3 were excluded from the further analysis as they represent the peptides interacting with MBP.  Twelve amino acid peptides thus obtained were searched for homology against </a:t>
            </a:r>
            <a:r>
              <a:rPr b="0" i="1" lang="en-US" sz="1100" spc="-1" strike="noStrike">
                <a:solidFill>
                  <a:srgbClr val="000000"/>
                </a:solidFill>
                <a:latin typeface="Calibri"/>
              </a:rPr>
              <a:t>A.thaliana</a:t>
            </a:r>
            <a:r>
              <a:rPr b="0" lang="en-US" sz="1100" spc="-1" strike="noStrike">
                <a:solidFill>
                  <a:srgbClr val="000000"/>
                </a:solidFill>
                <a:latin typeface="Calibri"/>
              </a:rPr>
              <a:t> protein database using ‘blastp’ programme with parameters adjusted for small peptide sequences. </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0" name="TextBox 3" descr=""/>
          <p:cNvPicPr/>
          <p:nvPr/>
        </p:nvPicPr>
        <p:blipFill>
          <a:blip r:embed="rId1"/>
          <a:stretch/>
        </p:blipFill>
        <p:spPr>
          <a:xfrm>
            <a:off x="901800" y="963720"/>
            <a:ext cx="5054400" cy="4005000"/>
          </a:xfrm>
          <a:prstGeom prst="rect">
            <a:avLst/>
          </a:prstGeom>
          <a:ln w="0">
            <a:noFill/>
          </a:ln>
        </p:spPr>
      </p:pic>
      <p:sp>
        <p:nvSpPr>
          <p:cNvPr id="51" name="Rectangle 4"/>
          <p:cNvSpPr/>
          <p:nvPr/>
        </p:nvSpPr>
        <p:spPr>
          <a:xfrm>
            <a:off x="838080" y="5257800"/>
            <a:ext cx="5105520" cy="928800"/>
          </a:xfrm>
          <a:prstGeom prst="rect">
            <a:avLst/>
          </a:prstGeom>
          <a:noFill/>
          <a:ln w="0">
            <a:noFill/>
          </a:ln>
        </p:spPr>
        <p:style>
          <a:lnRef idx="0"/>
          <a:fillRef idx="0"/>
          <a:effectRef idx="0"/>
          <a:fontRef idx="minor"/>
        </p:style>
        <p:txBody>
          <a:bodyPr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rPr>
              <a:t>Additional file 1b. Putative AC3 interacting proteins.</a:t>
            </a:r>
            <a:r>
              <a:rPr b="0" lang="en-US" sz="1100" spc="-1" strike="noStrike">
                <a:solidFill>
                  <a:srgbClr val="000000"/>
                </a:solidFill>
                <a:latin typeface="Calibri"/>
              </a:rPr>
              <a:t> Proteins that contain atleast five contiguous amino acids identical to the 12mer peptide obtained from phage display are listed.  The list includes various proteins from signaling, cell cycle, transcription activators, RNA and DNA  polymerases and RNA silencing machinery. The above list is only representative.</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6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5-04T14:31:33Z</dcterms:created>
  <dc:creator>Kalyan</dc:creator>
  <dc:description/>
  <dc:language>en-US</dc:language>
  <cp:lastModifiedBy>sravanthi</cp:lastModifiedBy>
  <dcterms:modified xsi:type="dcterms:W3CDTF">2011-03-02T12:31:23Z</dcterms:modified>
  <cp:revision>13</cp:revision>
  <dc:subject/>
  <dc:title>Slide 1</dc:title>
</cp:coreProperties>
</file>